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1"/>
  </p:notesMasterIdLst>
  <p:sldIdLst>
    <p:sldId id="256" r:id="rId2"/>
    <p:sldId id="257" r:id="rId3"/>
    <p:sldId id="258" r:id="rId4"/>
    <p:sldId id="262" r:id="rId5"/>
    <p:sldId id="259" r:id="rId6"/>
    <p:sldId id="261" r:id="rId7"/>
    <p:sldId id="260" r:id="rId8"/>
    <p:sldId id="264" r:id="rId9"/>
    <p:sldId id="265" r:id="rId10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87"/>
    <p:restoredTop sz="94586"/>
  </p:normalViewPr>
  <p:slideViewPr>
    <p:cSldViewPr snapToGrid="0" snapToObjects="1" showGuides="1">
      <p:cViewPr varScale="1">
        <p:scale>
          <a:sx n="104" d="100"/>
          <a:sy n="104" d="100"/>
        </p:scale>
        <p:origin x="1416" y="208"/>
      </p:cViewPr>
      <p:guideLst>
        <p:guide orient="horz" pos="218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34C72B-D4F7-F344-A7B7-5328486E3FA1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312BFB-C801-2B46-975B-4A8E087CAA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069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312BFB-C801-2B46-975B-4A8E087CAA94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865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312BFB-C801-2B46-975B-4A8E087CAA94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7670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9E4D3-F3E0-5842-8B3F-23DB3584DC03}" type="datetimeFigureOut">
              <a:rPr kumimoji="1" lang="ja-JP" altLang="en-US" smtClean="0"/>
              <a:t>2020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D7C042-EA45-1745-B5E8-28F0DF82EA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554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DF47739E-5525-41A3-ACAC-E6CFBE39EF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9867811"/>
              </p:ext>
            </p:extLst>
          </p:nvPr>
        </p:nvGraphicFramePr>
        <p:xfrm>
          <a:off x="111811" y="1349833"/>
          <a:ext cx="8920378" cy="4158333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861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514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88271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3766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Sequence length (bp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Number of spec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Taxo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24</a:t>
                      </a:r>
                      <a:endParaRPr lang="uk-UA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66382" marR="66382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olivian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it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36</a:t>
                      </a:r>
                      <a:endParaRPr lang="uk-UA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White-faced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k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uk-UA" sz="1400" u="none" strike="noStrike" dirty="0">
                          <a:effectLst/>
                          <a:latin typeface="+mn-lt"/>
                        </a:rPr>
                        <a:t>939</a:t>
                      </a:r>
                      <a:endParaRPr lang="uk-UA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Marmose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54</a:t>
                      </a:r>
                      <a:endParaRPr lang="uk-UA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ian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alm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ivet</a:t>
                      </a: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ru-RU" sz="1400" u="none" strike="noStrike">
                          <a:effectLst/>
                          <a:latin typeface="+mn-lt"/>
                        </a:rPr>
                        <a:t>957</a:t>
                      </a:r>
                      <a:endParaRPr lang="ru-RU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Cape Golden Mol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u="none" strike="noStrike">
                          <a:effectLst/>
                          <a:latin typeface="+mn-lt"/>
                        </a:rPr>
                        <a:t>963</a:t>
                      </a:r>
                      <a:endParaRPr lang="is-I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3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 err="1">
                          <a:effectLst/>
                          <a:latin typeface="+mn-lt"/>
                        </a:rPr>
                        <a:t>Hispaniolan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 err="1">
                          <a:effectLst/>
                          <a:latin typeface="+mn-lt"/>
                        </a:rPr>
                        <a:t>solenodon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, Wallaby, Gracile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shrew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mole</a:t>
                      </a: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u="none" strike="noStrike" dirty="0">
                          <a:effectLst/>
                          <a:latin typeface="+mn-lt"/>
                        </a:rPr>
                        <a:t>966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u="none" strike="noStrike" dirty="0">
                          <a:effectLst/>
                          <a:latin typeface="+mn-lt"/>
                        </a:rPr>
                        <a:t>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Star-nosed Mole, Shrew, Natal Long-fingered Ba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u="none" strike="noStrike">
                          <a:effectLst/>
                          <a:latin typeface="+mn-lt"/>
                        </a:rPr>
                        <a:t>969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Eastern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mole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,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Pale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spear-nosed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bat,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baseline="0" dirty="0" err="1">
                          <a:effectLst/>
                          <a:latin typeface="+mn-lt"/>
                        </a:rPr>
                        <a:t>Sebas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short-tailed bat, </a:t>
                      </a:r>
                      <a:r>
                        <a:rPr lang="en-US" sz="1400" u="none" strike="noStrike" dirty="0" err="1">
                          <a:effectLst/>
                          <a:latin typeface="+mn-lt"/>
                        </a:rPr>
                        <a:t>Sunda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 flying lemur, Tarsier,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cs-CZ" sz="1400" u="none" strike="noStrike">
                          <a:effectLst/>
                          <a:latin typeface="+mn-lt"/>
                        </a:rPr>
                        <a:t>972</a:t>
                      </a:r>
                      <a:endParaRPr lang="cs-CZ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cs-CZ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Most mammal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7132">
                <a:tc>
                  <a:txBody>
                    <a:bodyPr/>
                    <a:lstStyle/>
                    <a:p>
                      <a:pPr algn="l" fontAlgn="b"/>
                      <a:r>
                        <a:rPr lang="cs-CZ" sz="1400" u="none" strike="noStrike">
                          <a:effectLst/>
                          <a:latin typeface="+mn-lt"/>
                        </a:rPr>
                        <a:t>975</a:t>
                      </a:r>
                      <a:endParaRPr lang="cs-CZ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cs-CZ" sz="1400" u="none" strike="noStrike" dirty="0">
                          <a:effectLst/>
                          <a:latin typeface="+mn-lt"/>
                        </a:rPr>
                        <a:t>10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u="none" strike="noStrike" dirty="0">
                          <a:effectLst/>
                          <a:latin typeface="+mn-lt"/>
                        </a:rPr>
                        <a:t>Aardvark,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Koala, Great </a:t>
                      </a:r>
                      <a:r>
                        <a:rPr lang="en-US" sz="1400" u="none" strike="noStrike" dirty="0" err="1">
                          <a:effectLst/>
                          <a:latin typeface="+mn-lt"/>
                        </a:rPr>
                        <a:t>roundleaf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 bat, </a:t>
                      </a:r>
                      <a:r>
                        <a:rPr lang="en-US" sz="1400" u="none" strike="noStrike" dirty="0" err="1">
                          <a:effectLst/>
                          <a:latin typeface="+mn-lt"/>
                        </a:rPr>
                        <a:t>Perissodactyls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 (5 species),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baseline="0" dirty="0" err="1">
                          <a:effectLst/>
                          <a:latin typeface="+mn-lt"/>
                        </a:rPr>
                        <a:t>Ratel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,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Southern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grasshopper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mouse</a:t>
                      </a: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cs-CZ" sz="1400" u="none" strike="noStrike" dirty="0">
                          <a:effectLst/>
                          <a:latin typeface="+mn-lt"/>
                        </a:rPr>
                        <a:t>978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2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Gambian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giant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pouched</a:t>
                      </a:r>
                      <a:r>
                        <a:rPr lang="en-US" sz="1400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rat, Parnell's Mustached Ba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u="none" strike="noStrike" dirty="0">
                          <a:effectLst/>
                          <a:latin typeface="+mn-lt"/>
                        </a:rPr>
                        <a:t>99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outhern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ree-banded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rmadillo</a:t>
                      </a: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u="none" strike="noStrike">
                          <a:effectLst/>
                          <a:latin typeface="+mn-lt"/>
                        </a:rPr>
                        <a:t>993</a:t>
                      </a:r>
                      <a:endParaRPr lang="is-I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4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Xenathra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(4 species)</a:t>
                      </a: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3381">
                <a:tc>
                  <a:txBody>
                    <a:bodyPr/>
                    <a:lstStyle/>
                    <a:p>
                      <a:pPr algn="l" fontAlgn="b"/>
                      <a:r>
                        <a:rPr lang="fi-FI" sz="1400" u="none" strike="noStrike" dirty="0">
                          <a:effectLst/>
                          <a:latin typeface="+mn-lt"/>
                        </a:rPr>
                        <a:t>1044</a:t>
                      </a:r>
                      <a:endParaRPr lang="fi-FI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4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382" marR="66382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reater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ulldog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at</a:t>
                      </a:r>
                    </a:p>
                  </a:txBody>
                  <a:tcPr marL="66382" marR="66382" marT="0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2FDB3970-7034-8641-AF3C-DB9A8C1AC962}"/>
              </a:ext>
            </a:extLst>
          </p:cNvPr>
          <p:cNvSpPr/>
          <p:nvPr/>
        </p:nvSpPr>
        <p:spPr>
          <a:xfrm>
            <a:off x="49429" y="955761"/>
            <a:ext cx="831609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b="1" dirty="0"/>
              <a:t>Table S2. </a:t>
            </a:r>
            <a:r>
              <a:rPr lang="en" altLang="ja-JP" dirty="0"/>
              <a:t>Variation for the length of </a:t>
            </a:r>
            <a:r>
              <a:rPr lang="en" altLang="ja-JP" i="1" dirty="0"/>
              <a:t>ancV1R</a:t>
            </a:r>
            <a:r>
              <a:rPr lang="en" altLang="ja-JP" dirty="0"/>
              <a:t> in mammalians with intact sequences 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55622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AF7C3CC4-7568-4C2F-B87B-B902C70FA9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7894598"/>
              </p:ext>
            </p:extLst>
          </p:nvPr>
        </p:nvGraphicFramePr>
        <p:xfrm>
          <a:off x="1238595" y="659490"/>
          <a:ext cx="3884239" cy="195072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761938">
                  <a:extLst>
                    <a:ext uri="{9D8B030D-6E8A-4147-A177-3AD203B41FA5}">
                      <a16:colId xmlns:a16="http://schemas.microsoft.com/office/drawing/2014/main" val="1940282046"/>
                    </a:ext>
                  </a:extLst>
                </a:gridCol>
                <a:gridCol w="523813">
                  <a:extLst>
                    <a:ext uri="{9D8B030D-6E8A-4147-A177-3AD203B41FA5}">
                      <a16:colId xmlns:a16="http://schemas.microsoft.com/office/drawing/2014/main" val="1413287928"/>
                    </a:ext>
                  </a:extLst>
                </a:gridCol>
                <a:gridCol w="615888">
                  <a:extLst>
                    <a:ext uri="{9D8B030D-6E8A-4147-A177-3AD203B41FA5}">
                      <a16:colId xmlns:a16="http://schemas.microsoft.com/office/drawing/2014/main" val="1682228080"/>
                    </a:ext>
                  </a:extLst>
                </a:gridCol>
                <a:gridCol w="700025">
                  <a:extLst>
                    <a:ext uri="{9D8B030D-6E8A-4147-A177-3AD203B41FA5}">
                      <a16:colId xmlns:a16="http://schemas.microsoft.com/office/drawing/2014/main" val="3272863608"/>
                    </a:ext>
                  </a:extLst>
                </a:gridCol>
                <a:gridCol w="338075">
                  <a:extLst>
                    <a:ext uri="{9D8B030D-6E8A-4147-A177-3AD203B41FA5}">
                      <a16:colId xmlns:a16="http://schemas.microsoft.com/office/drawing/2014/main" val="1281986502"/>
                    </a:ext>
                  </a:extLst>
                </a:gridCol>
                <a:gridCol w="944500">
                  <a:extLst>
                    <a:ext uri="{9D8B030D-6E8A-4147-A177-3AD203B41FA5}">
                      <a16:colId xmlns:a16="http://schemas.microsoft.com/office/drawing/2014/main" val="1406527073"/>
                    </a:ext>
                  </a:extLst>
                </a:gridCol>
              </a:tblGrid>
              <a:tr h="49904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NO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cV1R(This study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5158926"/>
                  </a:ext>
                </a:extLst>
              </a:tr>
              <a:tr h="499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ondrichthy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fou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3679025"/>
                  </a:ext>
                </a:extLst>
              </a:tr>
              <a:tr h="49904">
                <a:tc rowSpan="14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teichthy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leoste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fou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6178945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a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0399607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ypteru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5551218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urgeon</a:t>
                      </a: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tact</a:t>
                      </a: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ngfis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?</a:t>
                      </a:r>
                      <a:r>
                        <a:rPr lang="en-US" sz="8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u="none" strike="noStrike" baseline="30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,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4463806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elacan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a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9576134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8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trapod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hibia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ur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-US" sz="8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a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1264616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udat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-US" sz="8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a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3499642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mnophion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1124347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ptil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uamat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-US" sz="8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6507891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ocodilia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</a:t>
                      </a:r>
                      <a:r>
                        <a:rPr lang="en-US" sz="8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stigi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7073864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udin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 </a:t>
                      </a:r>
                      <a:r>
                        <a:rPr lang="en-US" sz="8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stigi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3551374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rd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</a:t>
                      </a:r>
                      <a:r>
                        <a:rPr lang="en-US" sz="8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fou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9004881"/>
                  </a:ext>
                </a:extLst>
              </a:tr>
              <a:tr h="499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mma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e below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6800" marR="46800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9349383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FCF9EC30-A625-4848-97A7-9AF5305FA9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6243009"/>
              </p:ext>
            </p:extLst>
          </p:nvPr>
        </p:nvGraphicFramePr>
        <p:xfrm>
          <a:off x="1232289" y="2875655"/>
          <a:ext cx="6700147" cy="3354306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4375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645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2329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5027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7569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312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7722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0106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6709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0898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463141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129483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RPC2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ncV1R</a:t>
                      </a:r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(This study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6092"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NO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equenc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elective pressur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equenc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elective pressur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9483">
                <a:tc rowSpan="2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mma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latypu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 </a:t>
                      </a:r>
                      <a:r>
                        <a:rPr lang="en-US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rsupia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1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utheria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frotheri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nate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b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 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ther </a:t>
                      </a:r>
                      <a:r>
                        <a:rPr lang="en-US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frotheria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ea typeface="Times New Roman" charset="0"/>
                          <a:cs typeface="Times New Roman" panose="02020603050405020304" pitchFamily="18" charset="0"/>
                        </a:rPr>
                        <a:t>Xenarthr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charset="0"/>
                        <a:cs typeface="Times New Roman" panose="02020603050405020304" pitchFamily="18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4" marR="2874" marT="2874" marB="0" anchor="ctr"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1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aurasiatheri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rnivor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tter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,n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,n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inniped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walru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d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gative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g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ur sea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baseline="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d</a:t>
                      </a:r>
                      <a:endParaRPr lang="en-US" altLang="ja-JP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gative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g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rue sea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d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rutral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oth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ossa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ther </a:t>
                      </a:r>
                      <a:r>
                        <a:rPr lang="en-US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rnivoran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d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hiropter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arious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arious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arious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ee Table S8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etartiodactyl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etaceans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,f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op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,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Hartebeest, </a:t>
                      </a:r>
                      <a:r>
                        <a:rPr lang="en-US" sz="8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irol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m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oth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rtiodactyl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,m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erissodactyl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d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ther </a:t>
                      </a:r>
                      <a:r>
                        <a:rPr lang="en-US" sz="8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urasiatherians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d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6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uarchontoglir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rimat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tarrhin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baseline="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</a:t>
                      </a:r>
                      <a:r>
                        <a:rPr lang="en-US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 </a:t>
                      </a:r>
                      <a:r>
                        <a:rPr lang="en-US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w world monkey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wl monke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</a:t>
                      </a:r>
                      <a:r>
                        <a:rPr lang="mr-IN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r>
                        <a:rPr lang="en-US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800" u="none" strike="noStrike" baseline="30000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,g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utra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1744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ther New World monkey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</a:t>
                      </a:r>
                      <a:r>
                        <a:rPr lang="mr-IN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r>
                        <a:rPr lang="en-US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800" u="none" strike="noStrike" baseline="30000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,g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ther primat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u="none" strike="noStrike" baseline="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</a:t>
                      </a:r>
                      <a:endParaRPr lang="mr-IN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odenti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u="none" strike="noStrike" baseline="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</a:t>
                      </a:r>
                      <a:endParaRPr lang="mr-IN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29483">
                <a:tc v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ther </a:t>
                      </a:r>
                      <a:r>
                        <a:rPr lang="en-US" altLang="ja-JP" sz="8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uarchontoglire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u="none" strike="noStrike" baseline="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</a:t>
                      </a:r>
                      <a:r>
                        <a:rPr lang="en-US" altLang="ja-JP" sz="8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</a:t>
                      </a:r>
                      <a:endParaRPr lang="mr-IN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altLang="ja-JP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2874" marR="2874" marT="2874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9F53CD7-A905-4E88-AD6E-722DCE4AF496}"/>
              </a:ext>
            </a:extLst>
          </p:cNvPr>
          <p:cNvSpPr txBox="1"/>
          <p:nvPr/>
        </p:nvSpPr>
        <p:spPr>
          <a:xfrm>
            <a:off x="5715000" y="634777"/>
            <a:ext cx="2190405" cy="2154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* P: Present; A: Absent; R: Rudimentary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a Bhatnagar and </a:t>
            </a:r>
            <a:r>
              <a:rPr lang="en-US" altLang="ja-JP" sz="900" dirty="0" err="1">
                <a:latin typeface="Times New Roman" charset="0"/>
                <a:ea typeface="Times New Roman" charset="0"/>
                <a:cs typeface="Times New Roman" charset="0"/>
              </a:rPr>
              <a:t>Meisami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 1998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b Mackay-Sim et al. 1985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c </a:t>
            </a:r>
            <a:r>
              <a:rPr lang="en-US" altLang="ja-JP" sz="900" dirty="0" err="1">
                <a:latin typeface="Times New Roman" charset="0"/>
                <a:ea typeface="Times New Roman" charset="0"/>
                <a:cs typeface="Times New Roman" charset="0"/>
              </a:rPr>
              <a:t>Meisami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 and Bhatnagar 1998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d Switzer et al. 1980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e </a:t>
            </a:r>
            <a:r>
              <a:rPr lang="en-US" altLang="ja-JP" sz="900" dirty="0" err="1">
                <a:latin typeface="Times New Roman" charset="0"/>
                <a:ea typeface="Times New Roman" charset="0"/>
                <a:cs typeface="Times New Roman" charset="0"/>
              </a:rPr>
              <a:t>Wible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 and Bhatnagar 1996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f </a:t>
            </a:r>
            <a:r>
              <a:rPr lang="en-US" altLang="ja-JP" sz="900" dirty="0" err="1">
                <a:latin typeface="Times New Roman" charset="0"/>
                <a:ea typeface="Times New Roman" charset="0"/>
                <a:cs typeface="Times New Roman" charset="0"/>
              </a:rPr>
              <a:t>Oelschläiger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 1989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g Smith et al. 2011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h Yu et al. 2010</a:t>
            </a:r>
          </a:p>
          <a:p>
            <a:r>
              <a:rPr lang="en-US" altLang="ja-JP" sz="900" dirty="0" err="1">
                <a:latin typeface="Times New Roman" charset="0"/>
                <a:ea typeface="Times New Roman" charset="0"/>
                <a:cs typeface="Times New Roman" charset="0"/>
              </a:rPr>
              <a:t>i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900" dirty="0" err="1">
                <a:latin typeface="Times New Roman" charset="0"/>
                <a:ea typeface="Times New Roman" charset="0"/>
                <a:cs typeface="Times New Roman" charset="0"/>
              </a:rPr>
              <a:t>Yohe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 et al. 2017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j Liman and </a:t>
            </a:r>
            <a:r>
              <a:rPr lang="en-US" altLang="ja-JP" sz="900" dirty="0" err="1">
                <a:latin typeface="Times New Roman" charset="0"/>
                <a:ea typeface="Times New Roman" charset="0"/>
                <a:cs typeface="Times New Roman" charset="0"/>
              </a:rPr>
              <a:t>Innan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 2003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k González et al. 2010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l </a:t>
            </a:r>
            <a:r>
              <a:rPr lang="en-US" altLang="ja-JP" sz="900" dirty="0" err="1">
                <a:latin typeface="Times New Roman" charset="0"/>
                <a:ea typeface="Times New Roman" charset="0"/>
                <a:cs typeface="Times New Roman" charset="0"/>
              </a:rPr>
              <a:t>Nakamuta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 et al. 2012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m Heart et al. 1987</a:t>
            </a:r>
          </a:p>
          <a:p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n Hecker et al. 2019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8B22395-5EE6-A841-87A5-842DD461BC30}"/>
              </a:ext>
            </a:extLst>
          </p:cNvPr>
          <p:cNvSpPr/>
          <p:nvPr/>
        </p:nvSpPr>
        <p:spPr>
          <a:xfrm>
            <a:off x="988835" y="254786"/>
            <a:ext cx="815516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sz="1400" b="1" dirty="0"/>
              <a:t>Table S3. </a:t>
            </a:r>
            <a:r>
              <a:rPr lang="en" altLang="ja-JP" sz="1400" dirty="0"/>
              <a:t>Classification of vertebrate species used in this study and the status of the VNO, </a:t>
            </a:r>
            <a:r>
              <a:rPr lang="en" altLang="ja-JP" sz="1400" i="1" dirty="0"/>
              <a:t>ancV1R</a:t>
            </a:r>
            <a:r>
              <a:rPr lang="en" altLang="ja-JP" sz="1400" dirty="0"/>
              <a:t> and </a:t>
            </a:r>
            <a:r>
              <a:rPr lang="en" altLang="ja-JP" sz="1400" i="1" dirty="0"/>
              <a:t>TRPC2</a:t>
            </a:r>
            <a:endParaRPr lang="ja-JP" altLang="en-US" sz="1400" i="1"/>
          </a:p>
        </p:txBody>
      </p:sp>
    </p:spTree>
    <p:extLst>
      <p:ext uri="{BB962C8B-B14F-4D97-AF65-F5344CB8AC3E}">
        <p14:creationId xmlns:p14="http://schemas.microsoft.com/office/powerpoint/2010/main" val="21136809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E7069051-B6BE-4F9B-8525-D7A86258297C}"/>
              </a:ext>
            </a:extLst>
          </p:cNvPr>
          <p:cNvSpPr/>
          <p:nvPr/>
        </p:nvSpPr>
        <p:spPr>
          <a:xfrm>
            <a:off x="1143000" y="3119704"/>
            <a:ext cx="68580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/>
              <a:t>Abbreviations, </a:t>
            </a:r>
          </a:p>
          <a:p>
            <a:r>
              <a:rPr lang="en-US" altLang="ja-JP" sz="1400" dirty="0"/>
              <a:t>CF0 = frequencies for each codon are assumed to be equal; CF1 = codon frequencies are calculated from average nucleotide frequencies; CF2 = codon frequencies are calculated from average nucleotide frequencies at each of three codon positions; CF3 = codon frequencies are treated as free parameters. </a:t>
            </a:r>
          </a:p>
          <a:p>
            <a:r>
              <a:rPr lang="en-US" altLang="ja-JP" sz="1400" baseline="30000" dirty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Number of free parameters</a:t>
            </a:r>
          </a:p>
          <a:p>
            <a:r>
              <a:rPr lang="en-US" altLang="ja-JP" sz="1400" baseline="30000" dirty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AIC = 2*np – 2*</a:t>
            </a:r>
            <a:r>
              <a:rPr lang="en-US" altLang="ja-JP" sz="1400" dirty="0" err="1">
                <a:latin typeface="Times New Roman" charset="0"/>
                <a:ea typeface="Times New Roman" charset="0"/>
                <a:cs typeface="Times New Roman" charset="0"/>
              </a:rPr>
              <a:t>lnL</a:t>
            </a:r>
            <a:endParaRPr lang="en-US" altLang="ja-JP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US" altLang="ja-JP" sz="1400" baseline="30000" dirty="0">
                <a:latin typeface="Times New Roman" charset="0"/>
                <a:ea typeface="Times New Roman" charset="0"/>
                <a:cs typeface="Times New Roman" charset="0"/>
              </a:rPr>
              <a:t>c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Relative weight = exp(0.5*ΔAIC)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9FA7FBB6-9A35-4508-B06D-4646318FE3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1207044"/>
              </p:ext>
            </p:extLst>
          </p:nvPr>
        </p:nvGraphicFramePr>
        <p:xfrm>
          <a:off x="1143000" y="1538080"/>
          <a:ext cx="5112386" cy="10668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489268">
                  <a:extLst>
                    <a:ext uri="{9D8B030D-6E8A-4147-A177-3AD203B41FA5}">
                      <a16:colId xmlns:a16="http://schemas.microsoft.com/office/drawing/2014/main" val="3540236535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2223801446"/>
                    </a:ext>
                  </a:extLst>
                </a:gridCol>
                <a:gridCol w="494030">
                  <a:extLst>
                    <a:ext uri="{9D8B030D-6E8A-4147-A177-3AD203B41FA5}">
                      <a16:colId xmlns:a16="http://schemas.microsoft.com/office/drawing/2014/main" val="314973227"/>
                    </a:ext>
                  </a:extLst>
                </a:gridCol>
                <a:gridCol w="900430">
                  <a:extLst>
                    <a:ext uri="{9D8B030D-6E8A-4147-A177-3AD203B41FA5}">
                      <a16:colId xmlns:a16="http://schemas.microsoft.com/office/drawing/2014/main" val="3142491419"/>
                    </a:ext>
                  </a:extLst>
                </a:gridCol>
                <a:gridCol w="863918">
                  <a:extLst>
                    <a:ext uri="{9D8B030D-6E8A-4147-A177-3AD203B41FA5}">
                      <a16:colId xmlns:a16="http://schemas.microsoft.com/office/drawing/2014/main" val="299628712"/>
                    </a:ext>
                  </a:extLst>
                </a:gridCol>
                <a:gridCol w="1410335">
                  <a:extLst>
                    <a:ext uri="{9D8B030D-6E8A-4147-A177-3AD203B41FA5}">
                      <a16:colId xmlns:a16="http://schemas.microsoft.com/office/drawing/2014/main" val="1893381587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lnL</a:t>
                      </a:r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p </a:t>
                      </a:r>
                      <a:r>
                        <a:rPr lang="en-US" sz="1400" u="none" strike="noStrike" baseline="3000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a</a:t>
                      </a:r>
                      <a:endParaRPr lang="en-US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AIC </a:t>
                      </a:r>
                      <a:r>
                        <a:rPr lang="en-US" sz="1400" u="none" strike="noStrike" baseline="3000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b</a:t>
                      </a:r>
                      <a:endParaRPr lang="en-US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AI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Relative weight </a:t>
                      </a:r>
                      <a:r>
                        <a:rPr lang="en-US" sz="1400" u="none" strike="noStrike" baseline="3000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</a:t>
                      </a:r>
                      <a:endParaRPr lang="en-US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647314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F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42295.31</a:t>
                      </a: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84590.6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03195295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F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42930.30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hr-HR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85866.6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275.99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cs-CZ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8.35E-27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extLst>
                  <a:ext uri="{0D108BD9-81ED-4DB2-BD59-A6C34878D82A}">
                    <a16:rowId xmlns:a16="http://schemas.microsoft.com/office/drawing/2014/main" val="261600026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F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42962.92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hr-HR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85943.8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353.24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.41E-29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extLst>
                  <a:ext uri="{0D108BD9-81ED-4DB2-BD59-A6C34878D82A}">
                    <a16:rowId xmlns:a16="http://schemas.microsoft.com/office/drawing/2014/main" val="157039504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F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43405.77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6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86931.5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340.92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extLst>
                  <a:ext uri="{0D108BD9-81ED-4DB2-BD59-A6C34878D82A}">
                    <a16:rowId xmlns:a16="http://schemas.microsoft.com/office/drawing/2014/main" val="4106171192"/>
                  </a:ext>
                </a:extLst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1143000" y="1158087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>
                <a:latin typeface="Times New Roman" charset="0"/>
                <a:ea typeface="Times New Roman" charset="0"/>
                <a:cs typeface="Times New Roman" charset="0"/>
              </a:rPr>
              <a:t>ancV1R</a:t>
            </a:r>
            <a:endParaRPr kumimoji="1" lang="ja-JP" altLang="en-US" i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9BD71504-CEF1-B343-8116-086F8E9B6EDD}"/>
              </a:ext>
            </a:extLst>
          </p:cNvPr>
          <p:cNvSpPr/>
          <p:nvPr/>
        </p:nvSpPr>
        <p:spPr>
          <a:xfrm>
            <a:off x="1100926" y="496941"/>
            <a:ext cx="526868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sz="1400" b="1" dirty="0"/>
              <a:t>Table S4. </a:t>
            </a:r>
            <a:r>
              <a:rPr lang="en" altLang="ja-JP" sz="1400" dirty="0"/>
              <a:t>Akaike Information Criterion (AIC) comparisons of different codon frequency models in </a:t>
            </a:r>
            <a:r>
              <a:rPr lang="en" altLang="ja-JP" sz="1400" dirty="0" err="1"/>
              <a:t>codeml</a:t>
            </a:r>
            <a:r>
              <a:rPr lang="en" altLang="ja-JP" sz="1400" dirty="0"/>
              <a:t>. All comparisons were performed with the one category model</a:t>
            </a:r>
            <a:endParaRPr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332106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E7069051-B6BE-4F9B-8525-D7A86258297C}"/>
              </a:ext>
            </a:extLst>
          </p:cNvPr>
          <p:cNvSpPr/>
          <p:nvPr/>
        </p:nvSpPr>
        <p:spPr>
          <a:xfrm>
            <a:off x="1143000" y="3169131"/>
            <a:ext cx="68580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/>
              <a:t>Abbreviations, </a:t>
            </a:r>
          </a:p>
          <a:p>
            <a:r>
              <a:rPr lang="en-US" altLang="ja-JP" sz="1400" dirty="0"/>
              <a:t>CF0 = frequencies for each codon are assumed to be equal; CF1 = codon frequencies are calculated from average nucleotide frequencies; CF2 = codon frequencies are calculated from average nucleotide frequencies at each of three codon positions; CF3 = codon frequencies are treated as free parameters. </a:t>
            </a:r>
          </a:p>
          <a:p>
            <a:r>
              <a:rPr lang="en-US" altLang="ja-JP" sz="1400" baseline="30000" dirty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Number of free parameters</a:t>
            </a:r>
          </a:p>
          <a:p>
            <a:r>
              <a:rPr lang="en-US" altLang="ja-JP" sz="1400" baseline="30000" dirty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AIC = 2*np – 2*</a:t>
            </a:r>
            <a:r>
              <a:rPr lang="en-US" altLang="ja-JP" sz="1400" dirty="0" err="1">
                <a:latin typeface="Times New Roman" charset="0"/>
                <a:ea typeface="Times New Roman" charset="0"/>
                <a:cs typeface="Times New Roman" charset="0"/>
              </a:rPr>
              <a:t>lnL</a:t>
            </a:r>
            <a:endParaRPr lang="en-US" altLang="ja-JP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US" altLang="ja-JP" sz="1400" baseline="30000" dirty="0">
                <a:latin typeface="Times New Roman" charset="0"/>
                <a:ea typeface="Times New Roman" charset="0"/>
                <a:cs typeface="Times New Roman" charset="0"/>
              </a:rPr>
              <a:t>c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Relative weight = exp(0.5*ΔAIC)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9FA7FBB6-9A35-4508-B06D-4646318FE3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297810"/>
              </p:ext>
            </p:extLst>
          </p:nvPr>
        </p:nvGraphicFramePr>
        <p:xfrm>
          <a:off x="1143000" y="1538080"/>
          <a:ext cx="5112386" cy="10668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489268">
                  <a:extLst>
                    <a:ext uri="{9D8B030D-6E8A-4147-A177-3AD203B41FA5}">
                      <a16:colId xmlns:a16="http://schemas.microsoft.com/office/drawing/2014/main" val="3540236535"/>
                    </a:ext>
                  </a:extLst>
                </a:gridCol>
                <a:gridCol w="954405">
                  <a:extLst>
                    <a:ext uri="{9D8B030D-6E8A-4147-A177-3AD203B41FA5}">
                      <a16:colId xmlns:a16="http://schemas.microsoft.com/office/drawing/2014/main" val="2223801446"/>
                    </a:ext>
                  </a:extLst>
                </a:gridCol>
                <a:gridCol w="494030">
                  <a:extLst>
                    <a:ext uri="{9D8B030D-6E8A-4147-A177-3AD203B41FA5}">
                      <a16:colId xmlns:a16="http://schemas.microsoft.com/office/drawing/2014/main" val="314973227"/>
                    </a:ext>
                  </a:extLst>
                </a:gridCol>
                <a:gridCol w="900430">
                  <a:extLst>
                    <a:ext uri="{9D8B030D-6E8A-4147-A177-3AD203B41FA5}">
                      <a16:colId xmlns:a16="http://schemas.microsoft.com/office/drawing/2014/main" val="3142491419"/>
                    </a:ext>
                  </a:extLst>
                </a:gridCol>
                <a:gridCol w="863918">
                  <a:extLst>
                    <a:ext uri="{9D8B030D-6E8A-4147-A177-3AD203B41FA5}">
                      <a16:colId xmlns:a16="http://schemas.microsoft.com/office/drawing/2014/main" val="299628712"/>
                    </a:ext>
                  </a:extLst>
                </a:gridCol>
                <a:gridCol w="1410335">
                  <a:extLst>
                    <a:ext uri="{9D8B030D-6E8A-4147-A177-3AD203B41FA5}">
                      <a16:colId xmlns:a16="http://schemas.microsoft.com/office/drawing/2014/main" val="1893381587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lnL</a:t>
                      </a:r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np </a:t>
                      </a:r>
                      <a:r>
                        <a:rPr lang="en-US" sz="1400" u="none" strike="noStrike" baseline="3000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a</a:t>
                      </a:r>
                      <a:endParaRPr lang="en-US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AIC </a:t>
                      </a:r>
                      <a:r>
                        <a:rPr lang="en-US" sz="1400" u="none" strike="noStrike" baseline="3000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b</a:t>
                      </a:r>
                      <a:endParaRPr lang="en-US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l-GR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AI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Relative weight </a:t>
                      </a:r>
                      <a:r>
                        <a:rPr lang="en-US" sz="1400" u="none" strike="noStrike" baseline="30000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</a:t>
                      </a:r>
                      <a:endParaRPr lang="en-US" sz="14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647314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F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tr-TR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1268.8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i-FI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537.6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64.8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.3E-1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03195295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F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1233.4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472.8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T="0" marB="0" anchor="ctr"/>
                </a:tc>
                <a:extLst>
                  <a:ext uri="{0D108BD9-81ED-4DB2-BD59-A6C34878D82A}">
                    <a16:rowId xmlns:a16="http://schemas.microsoft.com/office/drawing/2014/main" val="261600026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F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1292.3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i-FI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602.6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29.75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.7E-29</a:t>
                      </a:r>
                    </a:p>
                  </a:txBody>
                  <a:tcPr marT="0" marB="0" anchor="ctr"/>
                </a:tc>
                <a:extLst>
                  <a:ext uri="{0D108BD9-81ED-4DB2-BD59-A6C34878D82A}">
                    <a16:rowId xmlns:a16="http://schemas.microsoft.com/office/drawing/2014/main" val="157039504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F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11281.71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u="none" strike="noStrike" dirty="0"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6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683.4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-210.58</a:t>
                      </a:r>
                    </a:p>
                  </a:txBody>
                  <a:tcPr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9E-46</a:t>
                      </a:r>
                    </a:p>
                  </a:txBody>
                  <a:tcPr marT="0" marB="0" anchor="ctr"/>
                </a:tc>
                <a:extLst>
                  <a:ext uri="{0D108BD9-81ED-4DB2-BD59-A6C34878D82A}">
                    <a16:rowId xmlns:a16="http://schemas.microsoft.com/office/drawing/2014/main" val="4106171192"/>
                  </a:ext>
                </a:extLst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1143000" y="1158087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>
                <a:latin typeface="Times New Roman" charset="0"/>
                <a:ea typeface="Times New Roman" charset="0"/>
                <a:cs typeface="Times New Roman" charset="0"/>
              </a:rPr>
              <a:t>TRPC2</a:t>
            </a:r>
            <a:endParaRPr kumimoji="1" lang="ja-JP" altLang="en-US" i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38B01683-3A50-A74D-85BE-0610856942B0}"/>
              </a:ext>
            </a:extLst>
          </p:cNvPr>
          <p:cNvSpPr/>
          <p:nvPr/>
        </p:nvSpPr>
        <p:spPr>
          <a:xfrm>
            <a:off x="1099750" y="420134"/>
            <a:ext cx="559761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solidFill>
                  <a:srgbClr val="000000"/>
                </a:solidFill>
                <a:ea typeface="游明朝" panose="02020400000000000000" pitchFamily="18" charset="-128"/>
              </a:rPr>
              <a:t>Table S5. </a:t>
            </a:r>
            <a:r>
              <a:rPr lang="en-US" altLang="ja-JP" sz="1400" dirty="0">
                <a:solidFill>
                  <a:srgbClr val="000000"/>
                </a:solidFill>
                <a:ea typeface="游明朝" panose="02020400000000000000" pitchFamily="18" charset="-128"/>
              </a:rPr>
              <a:t>Akaike Information Criterion (AIC) comparisons of different codon frequency models in </a:t>
            </a:r>
            <a:r>
              <a:rPr lang="en-US" altLang="ja-JP" sz="1400" dirty="0" err="1">
                <a:solidFill>
                  <a:srgbClr val="000000"/>
                </a:solidFill>
                <a:ea typeface="游明朝" panose="02020400000000000000" pitchFamily="18" charset="-128"/>
              </a:rPr>
              <a:t>codeml</a:t>
            </a:r>
            <a:r>
              <a:rPr lang="en-US" altLang="ja-JP" sz="1400" dirty="0">
                <a:solidFill>
                  <a:srgbClr val="000000"/>
                </a:solidFill>
                <a:ea typeface="游明朝" panose="02020400000000000000" pitchFamily="18" charset="-128"/>
              </a:rPr>
              <a:t> for </a:t>
            </a:r>
            <a:r>
              <a:rPr lang="en-US" altLang="ja-JP" sz="1400" i="1" dirty="0">
                <a:solidFill>
                  <a:srgbClr val="000000"/>
                </a:solidFill>
                <a:ea typeface="游明朝" panose="02020400000000000000" pitchFamily="18" charset="-128"/>
              </a:rPr>
              <a:t>TRPC2</a:t>
            </a:r>
            <a:r>
              <a:rPr lang="en-US" altLang="ja-JP" sz="1400" dirty="0">
                <a:solidFill>
                  <a:srgbClr val="000000"/>
                </a:solidFill>
                <a:ea typeface="游明朝" panose="02020400000000000000" pitchFamily="18" charset="-128"/>
              </a:rPr>
              <a:t> sequences. All comparisons were performed with the one category model.</a:t>
            </a:r>
            <a:r>
              <a:rPr lang="ja-JP" altLang="ja-JP" sz="1400"/>
              <a:t> </a:t>
            </a:r>
            <a:endParaRPr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11817021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2216225"/>
              </p:ext>
            </p:extLst>
          </p:nvPr>
        </p:nvGraphicFramePr>
        <p:xfrm>
          <a:off x="658343" y="1140010"/>
          <a:ext cx="7793087" cy="416901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81991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889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093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283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3787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8811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2046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762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oregroun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n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p </a:t>
                      </a:r>
                      <a:r>
                        <a:rPr lang="en-US" sz="14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-value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nate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453.81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i-FI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fi-FI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447.17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.7E-04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etarcean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7539.31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  <a:r>
                        <a:rPr lang="en-US" altLang="ja-JP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7525.44</a:t>
                      </a:r>
                      <a:r>
                        <a:rPr lang="mr-IN" altLang="ja-JP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endParaRPr lang="mr-IN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cs-CZ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.4</a:t>
                      </a:r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-0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7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tter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350.47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348.07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9 </a:t>
                      </a:r>
                      <a:endParaRPr lang="nb-NO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rue seal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386.64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hree dN/dS categori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381.64 </a:t>
                      </a:r>
                      <a:endParaRPr lang="mr-IN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68 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oss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216.94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dN/dS categori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215.11 </a:t>
                      </a:r>
                      <a:endParaRPr lang="is-I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5 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tarrhin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505.28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495.53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.0E-05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wl monke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4659.74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dN/dS categori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4659.10 </a:t>
                      </a:r>
                      <a:endParaRPr lang="mr-IN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hr-HR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6 </a:t>
                      </a:r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lcelaphine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ntelopes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6182.77</a:t>
                      </a: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four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4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6179.5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</a:t>
                      </a: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hr-H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95</a:t>
                      </a: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70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hiropteran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7660.35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502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hirteen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7642.88 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2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4.8E-04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4" name="正方形/長方形 3"/>
          <p:cNvSpPr/>
          <p:nvPr/>
        </p:nvSpPr>
        <p:spPr>
          <a:xfrm>
            <a:off x="658343" y="5671991"/>
            <a:ext cx="424827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aseline="30000" dirty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 Number of free parameters relative to each one </a:t>
            </a:r>
            <a:r>
              <a:rPr lang="en-US" altLang="ja-JP" sz="1100" dirty="0" err="1">
                <a:latin typeface="Times New Roman" charset="0"/>
                <a:ea typeface="Times New Roman" charset="0"/>
                <a:cs typeface="Times New Roman" charset="0"/>
              </a:rPr>
              <a:t>dN</a:t>
            </a:r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/</a:t>
            </a:r>
            <a:r>
              <a:rPr lang="en-US" altLang="ja-JP" sz="1100" dirty="0" err="1">
                <a:latin typeface="Times New Roman" charset="0"/>
                <a:ea typeface="Times New Roman" charset="0"/>
                <a:cs typeface="Times New Roman" charset="0"/>
              </a:rPr>
              <a:t>dS</a:t>
            </a:r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 category model.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658343" y="691117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>
                <a:latin typeface="Times New Roman" charset="0"/>
                <a:ea typeface="Times New Roman" charset="0"/>
                <a:cs typeface="Times New Roman" charset="0"/>
              </a:rPr>
              <a:t>ancV1R</a:t>
            </a:r>
            <a:endParaRPr kumimoji="1" lang="ja-JP" altLang="en-US" i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50FB78BA-B60A-9044-B09B-1A4B7FC4029C}"/>
              </a:ext>
            </a:extLst>
          </p:cNvPr>
          <p:cNvSpPr/>
          <p:nvPr/>
        </p:nvSpPr>
        <p:spPr>
          <a:xfrm>
            <a:off x="576943" y="338804"/>
            <a:ext cx="801100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sz="1400" b="1" dirty="0"/>
              <a:t>Table S6. </a:t>
            </a:r>
            <a:r>
              <a:rPr lang="en" altLang="ja-JP" sz="1400" dirty="0"/>
              <a:t>Summary of the results of selection analyses and likelihood ratio tests for ancV1R of each group </a:t>
            </a:r>
            <a:endParaRPr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3052122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127587"/>
              </p:ext>
            </p:extLst>
          </p:nvPr>
        </p:nvGraphicFramePr>
        <p:xfrm>
          <a:off x="658343" y="1140011"/>
          <a:ext cx="7793087" cy="4177247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81991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889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093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283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3787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8811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2046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994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oregroun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n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p </a:t>
                      </a:r>
                      <a:r>
                        <a:rPr lang="en-US" sz="1400" u="none" strike="noStrike" baseline="300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-value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nate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2310.6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i-FI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fi-FI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2300.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5.0</a:t>
                      </a:r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-0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etarcean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143.4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5098.7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cs-CZ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cs-CZ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tr-T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.2E-2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tter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044.2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037.9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4.2E-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rue seal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180.5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8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hre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168.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8.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7</a:t>
                      </a:r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-0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oss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2972.7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dN/dS categori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2968.8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7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5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tarrhin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801.3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742.1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.4E-2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wl monke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274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4.00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wo dN/dS categori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2741.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60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b-NO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lcelaphine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ntelopes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4201.1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hr-HR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four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4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4193.1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</a:t>
                      </a: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</a:t>
                      </a:r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01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hiropteran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: one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63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8.00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2417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1: thirteen 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N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/</a:t>
                      </a:r>
                      <a:r>
                        <a:rPr lang="en-US" sz="14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</a:t>
                      </a:r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categori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3595.9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4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1</a:t>
                      </a:r>
                      <a:endParaRPr lang="is-I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4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del0 vs model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4639" marR="4639" marT="463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.3E-1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4" name="正方形/長方形 3"/>
          <p:cNvSpPr/>
          <p:nvPr/>
        </p:nvSpPr>
        <p:spPr>
          <a:xfrm>
            <a:off x="658343" y="5671991"/>
            <a:ext cx="424827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aseline="30000" dirty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 Number of free parameters relative to each one </a:t>
            </a:r>
            <a:r>
              <a:rPr lang="en-US" altLang="ja-JP" sz="1100" dirty="0" err="1">
                <a:latin typeface="Times New Roman" charset="0"/>
                <a:ea typeface="Times New Roman" charset="0"/>
                <a:cs typeface="Times New Roman" charset="0"/>
              </a:rPr>
              <a:t>dN</a:t>
            </a:r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/</a:t>
            </a:r>
            <a:r>
              <a:rPr lang="en-US" altLang="ja-JP" sz="1100" dirty="0" err="1">
                <a:latin typeface="Times New Roman" charset="0"/>
                <a:ea typeface="Times New Roman" charset="0"/>
                <a:cs typeface="Times New Roman" charset="0"/>
              </a:rPr>
              <a:t>dS</a:t>
            </a:r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 category model.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658343" y="691117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>
                <a:latin typeface="Times New Roman" charset="0"/>
                <a:ea typeface="Times New Roman" charset="0"/>
                <a:cs typeface="Times New Roman" charset="0"/>
              </a:rPr>
              <a:t>TRPC2</a:t>
            </a:r>
            <a:endParaRPr kumimoji="1" lang="ja-JP" altLang="en-US" i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705C437-0A18-7B4F-9A37-8F599DD5D6E0}"/>
              </a:ext>
            </a:extLst>
          </p:cNvPr>
          <p:cNvSpPr/>
          <p:nvPr/>
        </p:nvSpPr>
        <p:spPr>
          <a:xfrm>
            <a:off x="576943" y="338804"/>
            <a:ext cx="801100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sz="1400" b="1" dirty="0"/>
              <a:t>Table S7. </a:t>
            </a:r>
            <a:r>
              <a:rPr lang="en" altLang="ja-JP" sz="1400" dirty="0"/>
              <a:t>Summary of the results of selection analyses and likelihood ratio tests for </a:t>
            </a:r>
            <a:r>
              <a:rPr lang="en" altLang="ja-JP" sz="1400" i="1" dirty="0"/>
              <a:t>TRPC</a:t>
            </a:r>
            <a:r>
              <a:rPr lang="en" altLang="ja-JP" sz="1400" dirty="0"/>
              <a:t>2 of each group </a:t>
            </a:r>
            <a:endParaRPr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7224410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7475791"/>
              </p:ext>
            </p:extLst>
          </p:nvPr>
        </p:nvGraphicFramePr>
        <p:xfrm>
          <a:off x="71105" y="372904"/>
          <a:ext cx="9001790" cy="603626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096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907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288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763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0056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0170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0170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19224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43451">
                <a:tc rowSpan="2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NO or AOB </a:t>
                      </a:r>
                      <a:r>
                        <a:rPr lang="en-US" sz="1100" u="none" strike="noStrike" baseline="30000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,b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RPC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ncV1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sembly nam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3451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Yohe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et al. 201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his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study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*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espertilionid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urina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urata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eae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ittle tube-nosed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8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bse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rowSpan="8"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rowSpan="8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t found</a:t>
                      </a: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urFea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yoti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avidii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avid's Myot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32734v1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yoti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yoti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reater mouse-eared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yoMyo_v1_BIUU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yotis lucifugus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ittle Brown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yoluc2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yotis brandtii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randt's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tr-TR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41265v1</a:t>
                      </a:r>
                      <a:endParaRPr lang="tr-T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ptesic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usc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ig Brown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??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ptFus1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ipistrellus pipistrellus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ommon pipistrell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ipPip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asiurus borealis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ed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asBor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niopterid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niopter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atalensi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atal Long-fingered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res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at.v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niopterus schreibersii 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chreibers</a:t>
                      </a:r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' long-fingered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nSch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it-IT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‎</a:t>
                      </a:r>
                      <a:r>
                        <a:rPr lang="it-IT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lossidae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adarida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rasiliensi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razilian free-tailed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bse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adBra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hyllostomid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rtibeus jamaicensis</a:t>
                      </a:r>
                      <a:endParaRPr lang="en-US" sz="11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amaican fruit-eating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 rowSpan="7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res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rtJam_v1_BIUU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rollia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erspicillat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eba's short-tailed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runcated</a:t>
                      </a: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rPer_v1_BIUU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hyllostom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discolor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ale spear-nosed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PhyDis1_v1.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onatia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aurophil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tripe-headed round-eared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onSau_v1_BIUU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noura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udifer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ailed tailless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noCau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esmod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otund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ommon vampire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a-DK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294091v2</a:t>
                      </a:r>
                      <a:endParaRPr lang="da-DK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cronycteri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irsut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ittle big-eared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cHir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rmoopid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teronot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arnellii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arnell's mustached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res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46540v1</a:t>
                      </a:r>
                      <a:endParaRPr lang="sk-SK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rmoop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lainvillei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ntillean ghost-faced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bse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orMeg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ctilionid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ctilio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eporin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reater bulldog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bse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cLep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hinolophid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hinoloph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errumequinum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reater Horseshoe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bse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46549v1</a:t>
                      </a:r>
                      <a:endParaRPr lang="sk-SK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hinoloph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inic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hinese rufous horseshoe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188883v1</a:t>
                      </a:r>
                      <a:endParaRPr lang="sk-SK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ipposiderid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ipposidero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alerit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antor's </a:t>
                      </a:r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oundleaf</a:t>
                      </a:r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bse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ipGal_v1_BIUU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ipposidero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armiger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reat roundleaf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189008v1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aseonycterid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aseonycteri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honglongyai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og-nosed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aTho_v1_BIUU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egadermatida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egaderma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yr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reater false vampire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bse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nta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46534v1</a:t>
                      </a:r>
                      <a:endParaRPr lang="sk-SK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teropodida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crogloss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obrin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ong-tongued fruit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 rowSpan="7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bs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cSob_v1_BIUU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idolon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elvum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traw-coloured fruit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t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fou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46528v1</a:t>
                      </a:r>
                      <a:endParaRPr lang="sk-SK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terop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lecto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lack Flying Fo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M32557v1</a:t>
                      </a:r>
                      <a:endParaRPr lang="sk-SK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2751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terop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ampyr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ava Fruit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vam_2.0</a:t>
                      </a:r>
                      <a:endParaRPr lang="nl-NL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5728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ousettu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egyptiac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gyptian Fruit B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mr-IN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?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t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fou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aegyp2.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ja-JP" alt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　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onycteris</a:t>
                      </a:r>
                      <a:r>
                        <a:rPr lang="en-US" sz="11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US" sz="1100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pelae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esser dawn b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27512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t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fou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ge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spe.v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3985" marR="3985" marT="3985" marB="0" anchor="ctr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</a:tbl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0" y="6405592"/>
            <a:ext cx="1922321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100" baseline="30000" dirty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r>
              <a:rPr lang="ja-JP" altLang="en-US" sz="1100" dirty="0">
                <a:latin typeface="Times New Roman" charset="0"/>
                <a:ea typeface="Times New Roman" charset="0"/>
                <a:cs typeface="Times New Roman" charset="0"/>
              </a:rPr>
              <a:t> Bhatnagar and Meisami 1998</a:t>
            </a:r>
            <a:endParaRPr lang="en-US" altLang="ja-JP" sz="1100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en-US" altLang="ja-JP" sz="1100" baseline="30000" dirty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100" dirty="0" err="1">
                <a:latin typeface="Times New Roman" charset="0"/>
                <a:ea typeface="Times New Roman" charset="0"/>
                <a:cs typeface="Times New Roman" charset="0"/>
              </a:rPr>
              <a:t>Wible</a:t>
            </a:r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 and Bhatnagar 1996</a:t>
            </a:r>
          </a:p>
        </p:txBody>
      </p:sp>
      <p:sp>
        <p:nvSpPr>
          <p:cNvPr id="4" name="正方形/長方形 3"/>
          <p:cNvSpPr/>
          <p:nvPr/>
        </p:nvSpPr>
        <p:spPr>
          <a:xfrm>
            <a:off x="1909606" y="6405592"/>
            <a:ext cx="169469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altLang="ja-JP" sz="1100" baseline="30000" dirty="0">
                <a:latin typeface="Times New Roman" charset="0"/>
                <a:ea typeface="Times New Roman" charset="0"/>
                <a:cs typeface="Times New Roman" charset="0"/>
              </a:rPr>
              <a:t>*</a:t>
            </a:r>
            <a:r>
              <a:rPr lang="fr-FR" altLang="ja-JP" sz="1100" dirty="0" err="1">
                <a:latin typeface="Times New Roman" charset="0"/>
                <a:ea typeface="Times New Roman" charset="0"/>
                <a:cs typeface="Times New Roman" charset="0"/>
              </a:rPr>
              <a:t>based</a:t>
            </a:r>
            <a:r>
              <a:rPr lang="fr-FR" altLang="ja-JP" sz="1100" dirty="0">
                <a:latin typeface="Times New Roman" charset="0"/>
                <a:ea typeface="Times New Roman" charset="0"/>
                <a:cs typeface="Times New Roman" charset="0"/>
              </a:rPr>
              <a:t> on exon 12 (720bp)</a:t>
            </a:r>
            <a:endParaRPr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B582BC0F-C5CF-394F-A337-1BA1974714D8}"/>
              </a:ext>
            </a:extLst>
          </p:cNvPr>
          <p:cNvSpPr/>
          <p:nvPr/>
        </p:nvSpPr>
        <p:spPr>
          <a:xfrm>
            <a:off x="39122" y="32658"/>
            <a:ext cx="736962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sz="1600" b="1" dirty="0"/>
              <a:t>Table S8. </a:t>
            </a:r>
            <a:r>
              <a:rPr lang="en" altLang="ja-JP" sz="1600" dirty="0"/>
              <a:t>Classification of bat species and the status of the VNO, </a:t>
            </a:r>
            <a:r>
              <a:rPr lang="en" altLang="ja-JP" sz="1600" i="1" dirty="0"/>
              <a:t>ancV1R</a:t>
            </a:r>
            <a:r>
              <a:rPr lang="en" altLang="ja-JP" sz="1600" dirty="0"/>
              <a:t> and </a:t>
            </a:r>
            <a:r>
              <a:rPr lang="en" altLang="ja-JP" sz="1600" i="1" dirty="0"/>
              <a:t>TRPC2</a:t>
            </a:r>
          </a:p>
        </p:txBody>
      </p:sp>
    </p:spTree>
    <p:extLst>
      <p:ext uri="{BB962C8B-B14F-4D97-AF65-F5344CB8AC3E}">
        <p14:creationId xmlns:p14="http://schemas.microsoft.com/office/powerpoint/2010/main" val="16697346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B06EED2-0FC4-7640-A166-F27D28469BD1}"/>
              </a:ext>
            </a:extLst>
          </p:cNvPr>
          <p:cNvSpPr/>
          <p:nvPr/>
        </p:nvSpPr>
        <p:spPr>
          <a:xfrm>
            <a:off x="1257301" y="1141113"/>
            <a:ext cx="699701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b="1"/>
              <a:t>Table S10A. </a:t>
            </a:r>
            <a:r>
              <a:rPr lang="en-US" altLang="ja-JP" dirty="0"/>
              <a:t>Results of the selection analysis based on the branch model (two categories) for new candidates with elevated </a:t>
            </a:r>
            <a:r>
              <a:rPr lang="en-US" altLang="ja-JP" dirty="0">
                <a:latin typeface="Symbol" pitchFamily="2" charset="2"/>
              </a:rPr>
              <a:t>w</a:t>
            </a:r>
            <a:r>
              <a:rPr lang="en-US" altLang="ja-JP" dirty="0"/>
              <a:t> values (&gt; 0.8) detected by free ratio model (Fig. S5)</a:t>
            </a:r>
            <a:r>
              <a:rPr lang="ja-JP" altLang="ja-JP"/>
              <a:t> </a:t>
            </a:r>
            <a:r>
              <a:rPr lang="en-US" altLang="ja-JP" dirty="0"/>
              <a:t>.</a:t>
            </a:r>
            <a:r>
              <a:rPr lang="ja-JP" altLang="ja-JP"/>
              <a:t> </a:t>
            </a:r>
            <a:endParaRPr lang="ja-JP" altLang="en-US"/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B5B0C993-8F5A-AE4D-A780-92E5395D82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5181605"/>
              </p:ext>
            </p:extLst>
          </p:nvPr>
        </p:nvGraphicFramePr>
        <p:xfrm>
          <a:off x="1511315" y="2188210"/>
          <a:ext cx="6121369" cy="227076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2998901">
                  <a:extLst>
                    <a:ext uri="{9D8B030D-6E8A-4147-A177-3AD203B41FA5}">
                      <a16:colId xmlns:a16="http://schemas.microsoft.com/office/drawing/2014/main" val="471997326"/>
                    </a:ext>
                  </a:extLst>
                </a:gridCol>
                <a:gridCol w="988541">
                  <a:extLst>
                    <a:ext uri="{9D8B030D-6E8A-4147-A177-3AD203B41FA5}">
                      <a16:colId xmlns:a16="http://schemas.microsoft.com/office/drawing/2014/main" val="2861555177"/>
                    </a:ext>
                  </a:extLst>
                </a:gridCol>
                <a:gridCol w="1317983">
                  <a:extLst>
                    <a:ext uri="{9D8B030D-6E8A-4147-A177-3AD203B41FA5}">
                      <a16:colId xmlns:a16="http://schemas.microsoft.com/office/drawing/2014/main" val="1877432555"/>
                    </a:ext>
                  </a:extLst>
                </a:gridCol>
                <a:gridCol w="815944">
                  <a:extLst>
                    <a:ext uri="{9D8B030D-6E8A-4147-A177-3AD203B41FA5}">
                      <a16:colId xmlns:a16="http://schemas.microsoft.com/office/drawing/2014/main" val="1465432346"/>
                    </a:ext>
                  </a:extLst>
                </a:gridCol>
              </a:tblGrid>
              <a:tr h="25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ancV1R</a:t>
                      </a:r>
                      <a:endParaRPr lang="ja-JP" altLang="en-US" sz="18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eg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background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527825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al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5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99505491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eaming_hairy_armadillo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5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>
                      <a:noFill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91745811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ser_pand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8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>
                      <a:noFill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272832815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Stripe-</a:t>
                      </a:r>
                      <a:r>
                        <a:rPr lang="en-US" sz="1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headed_round</a:t>
                      </a:r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eared_bat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1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5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64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>
                      <a:noFill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9224675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Tailed_tailless_bat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1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>
                      <a:noFill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80823108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aran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3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4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>
                      <a:noFill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57839137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ng-</a:t>
                      </a:r>
                      <a:r>
                        <a:rPr lang="en-US" sz="1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iled_lemur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4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7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>
                      <a:noFill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641359471"/>
                  </a:ext>
                </a:extLst>
              </a:tr>
            </a:tbl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5074D2E3-CF86-A64B-80DD-DFDC9CAD4F8F}"/>
              </a:ext>
            </a:extLst>
          </p:cNvPr>
          <p:cNvSpPr/>
          <p:nvPr/>
        </p:nvSpPr>
        <p:spPr>
          <a:xfrm>
            <a:off x="1603289" y="4617479"/>
            <a:ext cx="593742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/>
              <a:t>The species with elevated</a:t>
            </a:r>
            <a:r>
              <a:rPr lang="en-US" altLang="ja-JP" sz="1400" dirty="0">
                <a:latin typeface="Symbol" pitchFamily="2" charset="2"/>
              </a:rPr>
              <a:t> w</a:t>
            </a:r>
            <a:r>
              <a:rPr lang="en-US" altLang="ja-JP" sz="1400" dirty="0"/>
              <a:t> values by significant p-values &lt; 0.05 were highlighted by yellow </a:t>
            </a:r>
            <a:endParaRPr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25190610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672AA907-72F7-8B4F-8B8F-4172BF3B8A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6471596"/>
              </p:ext>
            </p:extLst>
          </p:nvPr>
        </p:nvGraphicFramePr>
        <p:xfrm>
          <a:off x="1555066" y="1926066"/>
          <a:ext cx="6859885" cy="170307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532375">
                  <a:extLst>
                    <a:ext uri="{9D8B030D-6E8A-4147-A177-3AD203B41FA5}">
                      <a16:colId xmlns:a16="http://schemas.microsoft.com/office/drawing/2014/main" val="1348990006"/>
                    </a:ext>
                  </a:extLst>
                </a:gridCol>
                <a:gridCol w="990289">
                  <a:extLst>
                    <a:ext uri="{9D8B030D-6E8A-4147-A177-3AD203B41FA5}">
                      <a16:colId xmlns:a16="http://schemas.microsoft.com/office/drawing/2014/main" val="1979601123"/>
                    </a:ext>
                  </a:extLst>
                </a:gridCol>
                <a:gridCol w="1193704">
                  <a:extLst>
                    <a:ext uri="{9D8B030D-6E8A-4147-A177-3AD203B41FA5}">
                      <a16:colId xmlns:a16="http://schemas.microsoft.com/office/drawing/2014/main" val="23080170"/>
                    </a:ext>
                  </a:extLst>
                </a:gridCol>
                <a:gridCol w="1045452">
                  <a:extLst>
                    <a:ext uri="{9D8B030D-6E8A-4147-A177-3AD203B41FA5}">
                      <a16:colId xmlns:a16="http://schemas.microsoft.com/office/drawing/2014/main" val="940049489"/>
                    </a:ext>
                  </a:extLst>
                </a:gridCol>
                <a:gridCol w="801991">
                  <a:extLst>
                    <a:ext uri="{9D8B030D-6E8A-4147-A177-3AD203B41FA5}">
                      <a16:colId xmlns:a16="http://schemas.microsoft.com/office/drawing/2014/main" val="4098948554"/>
                    </a:ext>
                  </a:extLst>
                </a:gridCol>
                <a:gridCol w="1296074">
                  <a:extLst>
                    <a:ext uri="{9D8B030D-6E8A-4147-A177-3AD203B41FA5}">
                      <a16:colId xmlns:a16="http://schemas.microsoft.com/office/drawing/2014/main" val="3510808733"/>
                    </a:ext>
                  </a:extLst>
                </a:gridCol>
              </a:tblGrid>
              <a:tr h="254000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n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rifying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163696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l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5077.96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7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allowed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6888196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eg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allowed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095010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ternativ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5077.88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2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4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7411590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eg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4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4603319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(null vs alt.)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04059822"/>
                  </a:ext>
                </a:extLst>
              </a:tr>
            </a:tbl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75F7C7A6-E0AB-CA4E-8D20-766CFCBCB70D}"/>
              </a:ext>
            </a:extLst>
          </p:cNvPr>
          <p:cNvSpPr/>
          <p:nvPr/>
        </p:nvSpPr>
        <p:spPr>
          <a:xfrm>
            <a:off x="1493279" y="1494950"/>
            <a:ext cx="14542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sser_panda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6324CCC7-9AFF-DB47-8D3E-F5FD0073F9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9468855"/>
              </p:ext>
            </p:extLst>
          </p:nvPr>
        </p:nvGraphicFramePr>
        <p:xfrm>
          <a:off x="1616411" y="4133612"/>
          <a:ext cx="6761468" cy="170307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482535">
                  <a:extLst>
                    <a:ext uri="{9D8B030D-6E8A-4147-A177-3AD203B41FA5}">
                      <a16:colId xmlns:a16="http://schemas.microsoft.com/office/drawing/2014/main" val="1348990006"/>
                    </a:ext>
                  </a:extLst>
                </a:gridCol>
                <a:gridCol w="966427">
                  <a:extLst>
                    <a:ext uri="{9D8B030D-6E8A-4147-A177-3AD203B41FA5}">
                      <a16:colId xmlns:a16="http://schemas.microsoft.com/office/drawing/2014/main" val="1979601123"/>
                    </a:ext>
                  </a:extLst>
                </a:gridCol>
                <a:gridCol w="1271231">
                  <a:extLst>
                    <a:ext uri="{9D8B030D-6E8A-4147-A177-3AD203B41FA5}">
                      <a16:colId xmlns:a16="http://schemas.microsoft.com/office/drawing/2014/main" val="23080170"/>
                    </a:ext>
                  </a:extLst>
                </a:gridCol>
                <a:gridCol w="1011449">
                  <a:extLst>
                    <a:ext uri="{9D8B030D-6E8A-4147-A177-3AD203B41FA5}">
                      <a16:colId xmlns:a16="http://schemas.microsoft.com/office/drawing/2014/main" val="940049489"/>
                    </a:ext>
                  </a:extLst>
                </a:gridCol>
                <a:gridCol w="775906">
                  <a:extLst>
                    <a:ext uri="{9D8B030D-6E8A-4147-A177-3AD203B41FA5}">
                      <a16:colId xmlns:a16="http://schemas.microsoft.com/office/drawing/2014/main" val="4098948554"/>
                    </a:ext>
                  </a:extLst>
                </a:gridCol>
                <a:gridCol w="1253920">
                  <a:extLst>
                    <a:ext uri="{9D8B030D-6E8A-4147-A177-3AD203B41FA5}">
                      <a16:colId xmlns:a16="http://schemas.microsoft.com/office/drawing/2014/main" val="3510808733"/>
                    </a:ext>
                  </a:extLst>
                </a:gridCol>
              </a:tblGrid>
              <a:tr h="254000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n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rifying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a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163696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l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14199.06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5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4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allowed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6888196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eg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allowed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095010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ternativ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14197.93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4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74115908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eg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4603319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(null vs alt.)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3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04059822"/>
                  </a:ext>
                </a:extLst>
              </a:tr>
            </a:tbl>
          </a:graphicData>
        </a:graphic>
      </p:graphicFrame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8D8BE0E7-ABA9-9E4F-9833-8363627FECFF}"/>
              </a:ext>
            </a:extLst>
          </p:cNvPr>
          <p:cNvSpPr/>
          <p:nvPr/>
        </p:nvSpPr>
        <p:spPr>
          <a:xfrm>
            <a:off x="1493279" y="3764280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carana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C8537B38-1169-E04F-A780-B6E5ADCF9C8A}"/>
              </a:ext>
            </a:extLst>
          </p:cNvPr>
          <p:cNvSpPr/>
          <p:nvPr/>
        </p:nvSpPr>
        <p:spPr>
          <a:xfrm>
            <a:off x="1417938" y="733340"/>
            <a:ext cx="667573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b="1" dirty="0"/>
              <a:t>Table S10B. </a:t>
            </a:r>
            <a:r>
              <a:rPr lang="en-US" altLang="ja-JP" dirty="0"/>
              <a:t>Results of the additional selection analysis based on based on branch-site model for Lesser panda and Pacarana.</a:t>
            </a:r>
            <a:r>
              <a:rPr lang="ja-JP" altLang="ja-JP"/>
              <a:t> 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5747660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143</TotalTime>
  <Words>2074</Words>
  <Application>Microsoft Macintosh PowerPoint</Application>
  <PresentationFormat>画面に合わせる (4:3)</PresentationFormat>
  <Paragraphs>855</Paragraphs>
  <Slides>9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9" baseType="lpstr">
      <vt:lpstr>游ゴシック</vt:lpstr>
      <vt:lpstr>游ゴシック</vt:lpstr>
      <vt:lpstr>游ゴシック Light</vt:lpstr>
      <vt:lpstr>游明朝</vt:lpstr>
      <vt:lpstr>Arial</vt:lpstr>
      <vt:lpstr>Calibri</vt:lpstr>
      <vt:lpstr>Calibri Light</vt:lpstr>
      <vt:lpstr>Symbol</vt:lpstr>
      <vt:lpstr>Times New Roman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Zhang Zicong</dc:creator>
  <cp:lastModifiedBy>Microsoft Office ユーザー</cp:lastModifiedBy>
  <cp:revision>78</cp:revision>
  <dcterms:created xsi:type="dcterms:W3CDTF">2019-06-07T04:58:30Z</dcterms:created>
  <dcterms:modified xsi:type="dcterms:W3CDTF">2020-03-21T01:24:42Z</dcterms:modified>
</cp:coreProperties>
</file>